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84D86A8-EC5C-4FBD-998C-BCB51FDF03D8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52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B8EB5F-1CC1-4F67-B53D-E241592B797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976559-48D4-4103-8A3C-92A580E7030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525E03-4518-4B49-A010-3016822F53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881D39-84E2-4CE5-98A2-E50DCAEBDE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6732FC-05C8-45A7-8FFE-EF70AE465F1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51B2E-111F-4637-A598-7E4A27B9ED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CF5CB2-B9A8-42D3-8479-7CF5B0BEE3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41AEAE-FB16-4E2C-9B93-6F1398C68C8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657147-866E-4730-BD7C-F171C847E5E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92D74-8276-440B-B804-0CC4FEDF7E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47F89-ACC4-4D29-B21E-963A8AF6A98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D54726-5182-4D7D-85A6-9D442D0CBE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8DA26-1635-4EEF-8570-45D3C90979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04DBC2-1A55-445B-88E2-FA8FA2EEFE4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4" descr="Exp__test_S1_v3.tif"/>
          <p:cNvPicPr/>
          <p:nvPr/>
        </p:nvPicPr>
        <p:blipFill>
          <a:blip r:embed="rId1"/>
          <a:stretch/>
        </p:blipFill>
        <p:spPr>
          <a:xfrm>
            <a:off x="527040" y="1085760"/>
            <a:ext cx="5797440" cy="5337360"/>
          </a:xfrm>
          <a:prstGeom prst="rect">
            <a:avLst/>
          </a:prstGeom>
          <a:ln w="0">
            <a:noFill/>
          </a:ln>
        </p:spPr>
      </p:pic>
      <p:sp>
        <p:nvSpPr>
          <p:cNvPr id="49" name="Rectangle 1"/>
          <p:cNvSpPr/>
          <p:nvPr/>
        </p:nvSpPr>
        <p:spPr>
          <a:xfrm>
            <a:off x="533520" y="6711480"/>
            <a:ext cx="579096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Figure S1: Alignment of PitB proteins of oral Mitis group streptococci and </a:t>
            </a:r>
            <a:r>
              <a:rPr b="1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pneumoniae.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PitBs of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orali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Uo5 and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. sp. C300 are not shown (identical to PitB of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sanguinis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ATCC49296).  Only residues different from the consensus sequence are indicated. The Signal peptides (SP) and cell wall sorting signals (CWSS) are underlined and the LPXTG-like motif is shown in bold. Signal peptides were predicted by the SignalP program. Conserved amino acids involved in intramolecular isopeptide bonds in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S. pneumoniae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Times New Roman"/>
              </a:rPr>
              <a:t> PitB are indicated by an asterisk followed by the number for bond 1 and 2, respectively. Accession numbers are as in Fig. 1. Alignment was performed with ClustalW software. 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6"/>
          <p:cNvSpPr/>
          <p:nvPr/>
        </p:nvSpPr>
        <p:spPr>
          <a:xfrm>
            <a:off x="558720" y="609480"/>
            <a:ext cx="5956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Alignment of PitB proteins of oral Mitis group streptococci and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S. pneumoniae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8-02T18:07:02Z</dcterms:created>
  <dc:creator>dzahner</dc:creator>
  <dc:description/>
  <dc:language>en-US</dc:language>
  <cp:lastModifiedBy>dzahner</cp:lastModifiedBy>
  <dcterms:modified xsi:type="dcterms:W3CDTF">2011-08-02T18:21:15Z</dcterms:modified>
  <cp:revision>2</cp:revision>
  <dc:subject/>
  <dc:title>Slide 1</dc:title>
</cp:coreProperties>
</file>